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82645-B667-4F69-9529-BB38633A66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04906-D2E7-444B-B93B-73BB13B15E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6D78E-BD8F-491B-8546-995CFD46CD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C7D1B-917B-4117-B67D-DEFEB0520D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6941B-0BE7-4F29-BB95-E8CF288582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6039F-F253-4571-A127-D125E46010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DB938-FCB3-4F75-923D-3A7110C08D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90821-67AD-4875-B26D-D41841B24C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02E5C-FDB5-47F4-8A2F-511D0A1D03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A056F-D74E-49CB-868E-63DF375FE3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BE6578-7601-41AD-8CDE-A7B01D04CE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C2194-8036-4C98-AAD0-87956E3275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02B023-91E2-40C5-9614-FF83AFC37E50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내용 개체 틀 3" descr=""/>
          <p:cNvPicPr/>
          <p:nvPr/>
        </p:nvPicPr>
        <p:blipFill>
          <a:blip r:embed="rId1"/>
          <a:stretch/>
        </p:blipFill>
        <p:spPr>
          <a:xfrm>
            <a:off x="920880" y="1722600"/>
            <a:ext cx="7662600" cy="3259080"/>
          </a:xfrm>
          <a:prstGeom prst="rect">
            <a:avLst/>
          </a:prstGeom>
          <a:ln w="0">
            <a:noFill/>
          </a:ln>
        </p:spPr>
      </p:pic>
      <p:sp>
        <p:nvSpPr>
          <p:cNvPr id="42" name="TextBox 8"/>
          <p:cNvSpPr/>
          <p:nvPr/>
        </p:nvSpPr>
        <p:spPr>
          <a:xfrm rot="16200000">
            <a:off x="-738000" y="2885760"/>
            <a:ext cx="2808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Standing handgrip strength (kg, men)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Box 11"/>
          <p:cNvSpPr/>
          <p:nvPr/>
        </p:nvSpPr>
        <p:spPr>
          <a:xfrm>
            <a:off x="6443640" y="2700360"/>
            <a:ext cx="45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TextBox 19"/>
          <p:cNvSpPr/>
          <p:nvPr/>
        </p:nvSpPr>
        <p:spPr>
          <a:xfrm>
            <a:off x="6443640" y="3645000"/>
            <a:ext cx="45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TextBox 15"/>
          <p:cNvSpPr/>
          <p:nvPr/>
        </p:nvSpPr>
        <p:spPr>
          <a:xfrm>
            <a:off x="2843280" y="2792520"/>
            <a:ext cx="45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baseline="30000">
                <a:solidFill>
                  <a:srgbClr val="000000"/>
                </a:solidFill>
                <a:latin typeface="Arial Narrow"/>
                <a:ea typeface="Times New Roman"/>
              </a:rPr>
              <a:t>¶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Box 20"/>
          <p:cNvSpPr/>
          <p:nvPr/>
        </p:nvSpPr>
        <p:spPr>
          <a:xfrm>
            <a:off x="2843280" y="3800520"/>
            <a:ext cx="45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baseline="30000">
                <a:solidFill>
                  <a:srgbClr val="000000"/>
                </a:solidFill>
                <a:latin typeface="Arial Narrow"/>
                <a:ea typeface="Times New Roman"/>
              </a:rPr>
              <a:t>¶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직선 연결선 21"/>
          <p:cNvSpPr/>
          <p:nvPr/>
        </p:nvSpPr>
        <p:spPr>
          <a:xfrm>
            <a:off x="1692360" y="5013360"/>
            <a:ext cx="273528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직선 연결선 22"/>
          <p:cNvSpPr/>
          <p:nvPr/>
        </p:nvSpPr>
        <p:spPr>
          <a:xfrm>
            <a:off x="5327640" y="5013360"/>
            <a:ext cx="27003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TextBox 23"/>
          <p:cNvSpPr/>
          <p:nvPr/>
        </p:nvSpPr>
        <p:spPr>
          <a:xfrm>
            <a:off x="1727280" y="5013360"/>
            <a:ext cx="270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ITT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TextBox 24"/>
          <p:cNvSpPr/>
          <p:nvPr/>
        </p:nvSpPr>
        <p:spPr>
          <a:xfrm>
            <a:off x="5327640" y="5013360"/>
            <a:ext cx="270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PP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직사각형 3"/>
          <p:cNvSpPr/>
          <p:nvPr/>
        </p:nvSpPr>
        <p:spPr>
          <a:xfrm>
            <a:off x="8280" y="12600"/>
            <a:ext cx="1296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 Narrow"/>
                <a:ea typeface="Arial"/>
              </a:rPr>
              <a:t>Fig. S1a</a:t>
            </a:r>
            <a:endParaRPr b="0" lang="en-US" sz="2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내용 개체 틀 3" descr=""/>
          <p:cNvPicPr/>
          <p:nvPr/>
        </p:nvPicPr>
        <p:blipFill>
          <a:blip r:embed="rId1"/>
          <a:stretch/>
        </p:blipFill>
        <p:spPr>
          <a:xfrm>
            <a:off x="1208160" y="1722600"/>
            <a:ext cx="6978600" cy="3260520"/>
          </a:xfrm>
          <a:prstGeom prst="rect">
            <a:avLst/>
          </a:prstGeom>
          <a:ln w="0">
            <a:noFill/>
          </a:ln>
        </p:spPr>
      </p:pic>
      <p:sp>
        <p:nvSpPr>
          <p:cNvPr id="53" name="TextBox 13"/>
          <p:cNvSpPr/>
          <p:nvPr/>
        </p:nvSpPr>
        <p:spPr>
          <a:xfrm rot="16200000">
            <a:off x="-249120" y="2887560"/>
            <a:ext cx="2808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Standing handgrip strength (kg, women)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직선 연결선 15"/>
          <p:cNvSpPr/>
          <p:nvPr/>
        </p:nvSpPr>
        <p:spPr>
          <a:xfrm>
            <a:off x="1908000" y="5040360"/>
            <a:ext cx="2448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직선 연결선 16"/>
          <p:cNvSpPr/>
          <p:nvPr/>
        </p:nvSpPr>
        <p:spPr>
          <a:xfrm>
            <a:off x="5184720" y="5040360"/>
            <a:ext cx="24829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TextBox 20"/>
          <p:cNvSpPr/>
          <p:nvPr/>
        </p:nvSpPr>
        <p:spPr>
          <a:xfrm>
            <a:off x="1979640" y="5040360"/>
            <a:ext cx="23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ITT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TextBox 21"/>
          <p:cNvSpPr/>
          <p:nvPr/>
        </p:nvSpPr>
        <p:spPr>
          <a:xfrm>
            <a:off x="5184720" y="5040360"/>
            <a:ext cx="248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PP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TextBox 19"/>
          <p:cNvSpPr/>
          <p:nvPr/>
        </p:nvSpPr>
        <p:spPr>
          <a:xfrm>
            <a:off x="7072200" y="3584520"/>
            <a:ext cx="45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baseline="30000">
                <a:solidFill>
                  <a:srgbClr val="000000"/>
                </a:solidFill>
                <a:latin typeface="Arial Narrow"/>
                <a:ea typeface="Arial"/>
              </a:rPr>
              <a:t>#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직사각형 3"/>
          <p:cNvSpPr/>
          <p:nvPr/>
        </p:nvSpPr>
        <p:spPr>
          <a:xfrm>
            <a:off x="25200" y="12600"/>
            <a:ext cx="1312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 Narrow"/>
                <a:ea typeface="Arial"/>
              </a:rPr>
              <a:t>Fig. S1b</a:t>
            </a:r>
            <a:endParaRPr b="0" lang="en-US" sz="2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1-26T01:40:59Z</dcterms:created>
  <dc:creator>차란희</dc:creator>
  <dc:description/>
  <dc:language>en-US</dc:language>
  <cp:lastModifiedBy>차란희</cp:lastModifiedBy>
  <dcterms:modified xsi:type="dcterms:W3CDTF">2021-06-03T08:33:42Z</dcterms:modified>
  <cp:revision>31</cp:revision>
  <dc:subject/>
  <dc:title>슬라이드 1</dc:title>
</cp:coreProperties>
</file>